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1341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A5FC2-659E-40AF-8A2C-8895645D11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77724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3696120"/>
            <a:ext cx="77724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A6172-C64E-40D3-BD78-474FB24B20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369612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369612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67464-7835-4BDC-A8D3-F6F59B16FE1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77336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77336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369612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369612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3696120"/>
            <a:ext cx="250236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0F9253-AF36-4B74-8AFE-F13585FF6B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773360"/>
            <a:ext cx="7772400" cy="368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562FF-070C-43EE-AC51-7E91A604D3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77724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18DEF-149A-40D9-BDC9-A84BBB74B1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37926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773360"/>
            <a:ext cx="37926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42EC0-9993-4E7A-9AB9-AA50951188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122B8C-E881-4BA9-BF71-9AAEC4EE4DB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546120"/>
            <a:ext cx="7772400" cy="4740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2A6B7F-9ED6-4FAD-A234-F564A6AC01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773360"/>
            <a:ext cx="37926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369612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2420E-4EEE-4B6F-9969-B17CE28A84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37926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369612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AC556-2B1B-44CF-A77A-F9AF702B88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773360"/>
            <a:ext cx="37926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3696120"/>
            <a:ext cx="7772400" cy="175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D9BA6-6F99-4D05-9C86-B50A4A5025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546120"/>
            <a:ext cx="7772400" cy="102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773360"/>
            <a:ext cx="7772400" cy="3681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9000"/>
          </a:bodyPr>
          <a:p>
            <a:pPr marL="305280" indent="-3052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60960" indent="-2541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17000" indent="-2034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424160" indent="-2034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30960" indent="-203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30960" indent="-203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30960" indent="-2034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5589360"/>
            <a:ext cx="1905120" cy="40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5589360"/>
            <a:ext cx="2895840" cy="40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5589360"/>
            <a:ext cx="1905120" cy="409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C221C0-5374-46DD-8D59-DE21112169A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93760" y="228600"/>
            <a:ext cx="8710560" cy="548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Protein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Predicted size (found)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Function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        GSAO effec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Cyclin D3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33 (38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cell cycle regulator (binds CDKs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DFF45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45 (44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DNA fragmentation factor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DLP-1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84/79 (89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ecretion? dynamin-like protein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E2F1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46(46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DNA binding protein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GSK3 bet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46 (50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otein kinase (metabolism, p53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Heme oxygenase 2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36 (40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immune modulation? inflammation?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Hic-5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50 (58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daptor/kinase target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Hsp70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70 (75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heat shock protein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ISGF3gamm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48 (35+49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transcription factor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JAK1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130 (119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otein kinase (IFNs, cytokines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LAT </a:t>
            </a:r>
            <a:r>
              <a:rPr b="1" lang="en-GB" sz="1400" spc="-1" strike="noStrike">
                <a:solidFill>
                  <a:srgbClr val="000000"/>
                </a:solidFill>
                <a:latin typeface="Times New Roman"/>
              </a:rPr>
              <a:t>?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 u="sng">
                <a:solidFill>
                  <a:srgbClr val="000000"/>
                </a:solidFill>
                <a:uFillTx/>
                <a:latin typeface="Times New Roman"/>
              </a:rPr>
              <a:t>42 (17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daptor/kinase target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TP1B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50 (48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rotein phosphatase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TP1C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68 (73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rotein phosphatase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KC beta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80 (72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rotein kinase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KC theta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79 (67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otein kinase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RK1/PKN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120 (110+118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protein kinase (Rho target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K2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140 (123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otein kinase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Rab8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24 (24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small GTPase (vesicle transport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Rho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21 (21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mall GTPase, actin reorganisation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RhoGDI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28 (26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GTPase regulation (Rac, Rho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hcC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69/55 (60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adaptor/kinase target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Stat6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100 (120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transcription factor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VASP </a:t>
            </a:r>
            <a:r>
              <a:rPr b="1" lang="en-GB" sz="1400" spc="-1" strike="noStrike">
                <a:solidFill>
                  <a:srgbClr val="333399"/>
                </a:solidFill>
                <a:latin typeface="Times New Roman"/>
              </a:rPr>
              <a:t>?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 u="sng">
                <a:solidFill>
                  <a:srgbClr val="333399"/>
                </a:solidFill>
                <a:uFillTx/>
                <a:latin typeface="Times New Roman"/>
              </a:rPr>
              <a:t>46 (18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adaptor/kinase target (actin, motility)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333399"/>
                </a:solidFill>
                <a:latin typeface="Times New Roman"/>
              </a:rPr>
              <a:t>    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ZAP70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70 (79)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protein kinase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	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   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926480" y="609480"/>
            <a:ext cx="304560" cy="520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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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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</a:t>
            </a:r>
            <a:r>
              <a:rPr b="1" lang="en-US" sz="1400" spc="-1" strike="noStrike" u="sng">
                <a:solidFill>
                  <a:srgbClr val="333399"/>
                </a:solidFill>
                <a:uFillTx/>
                <a:latin typeface="Symbol"/>
                <a:ea typeface="Symbol"/>
              </a:rPr>
              <a:t></a:t>
            </a:r>
            <a:r>
              <a:rPr b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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3-06T12:02:26Z</dcterms:created>
  <dc:creator>everybody</dc:creator>
  <dc:description/>
  <dc:language>en-US</dc:language>
  <cp:lastModifiedBy>everybody</cp:lastModifiedBy>
  <dcterms:modified xsi:type="dcterms:W3CDTF">2006-03-06T12:19:40Z</dcterms:modified>
  <cp:revision>2</cp:revision>
  <dc:subject/>
  <dc:title>PowerPoint Presentation</dc:title>
</cp:coreProperties>
</file>